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093D744-50AE-4B75-8399-8687AA4877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023EE9C-B787-437B-B2AC-444C790969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9C03F3D-8281-4C73-B93F-3B6AD74FC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A9F97-BAF7-4CA7-9BB6-8881C7E90E2E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C5E4AC9-6531-46F7-8132-71452E259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23EF48C-FE03-4A90-AB0B-D2D074554A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6D5C5-157B-43EC-BD98-FBF39D46D6C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6979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9548126-3AA5-4CE3-83A9-3E1627F92B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BA2C3DF-98D5-40FD-AB67-A015912C90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1ECD2D9-B503-4D76-A7D8-AC690C784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A9F97-BAF7-4CA7-9BB6-8881C7E90E2E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B94EEEA-F0AB-4789-90CC-99D5FE392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F6D1A65-6660-4566-8F60-1A3B0D800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6D5C5-157B-43EC-BD98-FBF39D46D6C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22378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409DEA23-5AB2-4BB3-964A-55205A5454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46EA457-E256-4249-849C-E695AC04F3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81767D0-ED7F-4143-AFF6-1C408E92C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A9F97-BAF7-4CA7-9BB6-8881C7E90E2E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3616054-80DA-4AC9-B134-B58F0FB78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DF1D677-E2A4-417F-887B-5B012A23C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6D5C5-157B-43EC-BD98-FBF39D46D6C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5065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59E1BF2-1D3F-4100-B3D7-19C6C61033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DA791F5-B0B6-43E6-AFAB-D2404B9743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2367595-CC86-4897-9362-C8ADF6278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A9F97-BAF7-4CA7-9BB6-8881C7E90E2E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DD2D82B-93E5-4000-B2F9-8C0F782D4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C491E06-DB61-41BE-B36A-C7639E4F15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6D5C5-157B-43EC-BD98-FBF39D46D6C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19474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F757429-2DBC-4519-AF72-9C5EF7C2B9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BBBCDF0-11D8-45BE-A13C-8ED41A81D2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C64B27C-B851-461D-8011-134825188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A9F97-BAF7-4CA7-9BB6-8881C7E90E2E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3C2CB0B-2917-4688-AE4B-23370C55BA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F14F8CE-2201-46C4-ACCA-5C857A72E0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6D5C5-157B-43EC-BD98-FBF39D46D6C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5168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D397362-2604-4E84-88F5-28420FDEBB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6C0DE18-98B0-478B-99B8-091EF19424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57B1AA6-69E2-4E04-8540-0ACC62F7A2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30789F0-AAB1-4817-A5CF-8616E7B6FA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A9F97-BAF7-4CA7-9BB6-8881C7E90E2E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F9A4C33-C2F9-4BE1-9F68-6AF8ECD91A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1DDE737-EB81-4088-BD35-3E8BF9E20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6D5C5-157B-43EC-BD98-FBF39D46D6C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934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35D5D5F-E3B5-4ED3-AFCF-B6F582E8F9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057CA03-1D80-4FA2-A28E-0A943D36A8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9C9C073-5A72-4B6B-BA44-5CCA4516D1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713BCFA-1DE7-442B-81B6-E7FD095986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72C4CA6A-FC7E-4E4A-BAE3-8972634D99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E34F6CCA-268A-4821-9D9E-0936655C3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A9F97-BAF7-4CA7-9BB6-8881C7E90E2E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FCF6A76-0C47-46ED-9FEB-9D4ED22E74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9959BA6-8BD9-422E-83C3-A6786C7FB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6D5C5-157B-43EC-BD98-FBF39D46D6C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4702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1E8FF71-CFF3-4690-9F43-A7E62FA9DA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4864EB1B-7411-4E6A-80F7-FE4588D29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A9F97-BAF7-4CA7-9BB6-8881C7E90E2E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0927449C-018D-436B-B441-CBEA35077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23C6882B-6CC2-49F5-AA0E-B2DA0833C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6D5C5-157B-43EC-BD98-FBF39D46D6C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7248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4BE383C-1DE1-40EB-A2E0-47692CE16D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A9F97-BAF7-4CA7-9BB6-8881C7E90E2E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2A79148-07C8-4044-930B-B920835A3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E813418-7967-419B-8680-25EF49090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6D5C5-157B-43EC-BD98-FBF39D46D6C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9700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BA18ED5-CDA3-4EB4-B4C9-AEEFC79479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9345620-CF0E-4178-92AB-03F2266693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04095AB-48FE-4736-8ABB-2D62389C03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3588208-C02F-4D34-A2FE-61C8EF4A2C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A9F97-BAF7-4CA7-9BB6-8881C7E90E2E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EF41E6D-62EB-4F48-BC54-F300E2B9E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05F51B6-8365-43F2-83B5-CB8AEE052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6D5C5-157B-43EC-BD98-FBF39D46D6C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252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37D45B6-F2C9-455E-B934-DB7E271A7A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C66538F-7D5C-4318-88AB-4AC0D05A24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11D732E-0CC0-4BA0-AD28-D5B5644DAA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B6AA5AF-C95F-4797-8B1D-3E695E142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A9F97-BAF7-4CA7-9BB6-8881C7E90E2E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D5F900D-DC49-406D-AE65-D917639EF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A1A4C0F-A772-4BA7-A0A3-CB13AC92F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6D5C5-157B-43EC-BD98-FBF39D46D6C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49125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9771007-EBB0-4295-9765-FB202F1297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7E5B85B-931C-441F-A726-28E221944E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1E05B29-1EFD-4571-B6DC-E40756E962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BA9F97-BAF7-4CA7-9BB6-8881C7E90E2E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0C78FFD-D6DB-4F49-AF09-30C897796C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6B073E8-3FCE-4CDC-9391-6E33777DD5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46D5C5-157B-43EC-BD98-FBF39D46D6C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8288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5.wdp"/><Relationship Id="rId18" Type="http://schemas.openxmlformats.org/officeDocument/2006/relationships/image" Target="../media/image11.jpeg"/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12" Type="http://schemas.openxmlformats.org/officeDocument/2006/relationships/image" Target="../media/image7.png"/><Relationship Id="rId17" Type="http://schemas.openxmlformats.org/officeDocument/2006/relationships/image" Target="../media/image10.png"/><Relationship Id="rId2" Type="http://schemas.openxmlformats.org/officeDocument/2006/relationships/image" Target="../media/image1.png"/><Relationship Id="rId16" Type="http://schemas.openxmlformats.org/officeDocument/2006/relationships/image" Target="../media/image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microsoft.com/office/2007/relationships/hdphoto" Target="../media/hdphoto6.wdp"/><Relationship Id="rId10" Type="http://schemas.openxmlformats.org/officeDocument/2006/relationships/image" Target="../media/image6.png"/><Relationship Id="rId4" Type="http://schemas.openxmlformats.org/officeDocument/2006/relationships/image" Target="../media/image3.png"/><Relationship Id="rId9" Type="http://schemas.microsoft.com/office/2007/relationships/hdphoto" Target="../media/hdphoto3.wdp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Immagine 83">
            <a:extLst>
              <a:ext uri="{FF2B5EF4-FFF2-40B4-BE49-F238E27FC236}">
                <a16:creationId xmlns:a16="http://schemas.microsoft.com/office/drawing/2014/main" id="{29AD32C4-19B5-4FD9-BC15-5DEBCF07AD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4037" y="771918"/>
            <a:ext cx="222962" cy="222962"/>
          </a:xfrm>
          <a:prstGeom prst="rect">
            <a:avLst/>
          </a:prstGeom>
        </p:spPr>
      </p:pic>
      <p:pic>
        <p:nvPicPr>
          <p:cNvPr id="85" name="Immagine 84">
            <a:extLst>
              <a:ext uri="{FF2B5EF4-FFF2-40B4-BE49-F238E27FC236}">
                <a16:creationId xmlns:a16="http://schemas.microsoft.com/office/drawing/2014/main" id="{F936CF78-B638-4C68-BFFE-0017734C76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92849" y="771918"/>
            <a:ext cx="222962" cy="222962"/>
          </a:xfrm>
          <a:prstGeom prst="rect">
            <a:avLst/>
          </a:prstGeom>
        </p:spPr>
      </p:pic>
      <p:pic>
        <p:nvPicPr>
          <p:cNvPr id="86" name="Immagine 85">
            <a:extLst>
              <a:ext uri="{FF2B5EF4-FFF2-40B4-BE49-F238E27FC236}">
                <a16:creationId xmlns:a16="http://schemas.microsoft.com/office/drawing/2014/main" id="{E0B48494-0C60-4334-8E82-D8A0513E2E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45702" y="771918"/>
            <a:ext cx="222962" cy="222962"/>
          </a:xfrm>
          <a:prstGeom prst="rect">
            <a:avLst/>
          </a:prstGeom>
        </p:spPr>
      </p:pic>
      <p:pic>
        <p:nvPicPr>
          <p:cNvPr id="93" name="Immagine 92">
            <a:extLst>
              <a:ext uri="{FF2B5EF4-FFF2-40B4-BE49-F238E27FC236}">
                <a16:creationId xmlns:a16="http://schemas.microsoft.com/office/drawing/2014/main" id="{77322EB5-1142-4D81-AAF1-D24E6778E9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26388" y="771918"/>
            <a:ext cx="222962" cy="222962"/>
          </a:xfrm>
          <a:prstGeom prst="rect">
            <a:avLst/>
          </a:prstGeom>
        </p:spPr>
      </p:pic>
      <p:sp>
        <p:nvSpPr>
          <p:cNvPr id="387" name="CasellaDiTesto 483">
            <a:extLst>
              <a:ext uri="{FF2B5EF4-FFF2-40B4-BE49-F238E27FC236}">
                <a16:creationId xmlns:a16="http://schemas.microsoft.com/office/drawing/2014/main" id="{C1324F01-8255-45BA-ADEF-311B7AB2BF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3193" y="918130"/>
            <a:ext cx="1073860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MS PGothic" panose="020B0600070205080204" pitchFamily="34" charset="-128"/>
              </a:rPr>
              <a:t>FFPE </a:t>
            </a:r>
            <a:r>
              <a:rPr kumimoji="0" lang="it-IT" altLang="it-IT" sz="7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MS PGothic" panose="020B0600070205080204" pitchFamily="34" charset="-128"/>
              </a:rPr>
              <a:t>blocks</a:t>
            </a:r>
            <a:endParaRPr kumimoji="0" lang="it-IT" altLang="it-IT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MS PGothic" panose="020B0600070205080204" pitchFamily="34" charset="-128"/>
            </a:endParaRPr>
          </a:p>
        </p:txBody>
      </p:sp>
      <p:sp>
        <p:nvSpPr>
          <p:cNvPr id="393" name="CasellaDiTesto 482">
            <a:extLst>
              <a:ext uri="{FF2B5EF4-FFF2-40B4-BE49-F238E27FC236}">
                <a16:creationId xmlns:a16="http://schemas.microsoft.com/office/drawing/2014/main" id="{A658ADA6-38B0-48E1-A5BE-F6AB8A59CD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7589" y="402759"/>
            <a:ext cx="88931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9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rchival</a:t>
            </a:r>
            <a:endParaRPr kumimoji="0" lang="it-IT" altLang="it-IT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it-IT" altLang="it-IT" sz="900" b="1" kern="0" dirty="0">
                <a:solidFill>
                  <a:prstClr val="black"/>
                </a:solidFill>
              </a:rPr>
              <a:t>tumor </a:t>
            </a:r>
            <a:r>
              <a:rPr kumimoji="0" lang="it-IT" altLang="it-IT" sz="9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tissues</a:t>
            </a:r>
            <a:endParaRPr kumimoji="0" lang="it-IT" altLang="it-IT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pic>
        <p:nvPicPr>
          <p:cNvPr id="395" name="Immagine 394">
            <a:extLst>
              <a:ext uri="{FF2B5EF4-FFF2-40B4-BE49-F238E27FC236}">
                <a16:creationId xmlns:a16="http://schemas.microsoft.com/office/drawing/2014/main" id="{965A7FE5-3885-4955-A51A-43ACEC3F0D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8045" y="1159893"/>
            <a:ext cx="258749" cy="180000"/>
          </a:xfrm>
          <a:prstGeom prst="rect">
            <a:avLst/>
          </a:prstGeom>
        </p:spPr>
      </p:pic>
      <p:grpSp>
        <p:nvGrpSpPr>
          <p:cNvPr id="407" name="Gruppo 406">
            <a:extLst>
              <a:ext uri="{FF2B5EF4-FFF2-40B4-BE49-F238E27FC236}">
                <a16:creationId xmlns:a16="http://schemas.microsoft.com/office/drawing/2014/main" id="{2760971A-D90E-4E57-8224-26CACA14240D}"/>
              </a:ext>
            </a:extLst>
          </p:cNvPr>
          <p:cNvGrpSpPr/>
          <p:nvPr/>
        </p:nvGrpSpPr>
        <p:grpSpPr>
          <a:xfrm flipH="1">
            <a:off x="1931045" y="863687"/>
            <a:ext cx="216000" cy="475200"/>
            <a:chOff x="12607615" y="16745731"/>
            <a:chExt cx="609600" cy="1228781"/>
          </a:xfrm>
        </p:grpSpPr>
        <p:pic>
          <p:nvPicPr>
            <p:cNvPr id="472" name="Immagine 471">
              <a:extLst>
                <a:ext uri="{FF2B5EF4-FFF2-40B4-BE49-F238E27FC236}">
                  <a16:creationId xmlns:a16="http://schemas.microsoft.com/office/drawing/2014/main" id="{7BE3A027-A5A0-469F-9DD1-6B7FA7CC0BC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duotone>
                <a:schemeClr val="bg2">
                  <a:shade val="45000"/>
                  <a:satMod val="135000"/>
                </a:schemeClr>
                <a:prstClr val="white"/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0" b="100000" l="1563" r="1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607615" y="16755312"/>
              <a:ext cx="609600" cy="1219200"/>
            </a:xfrm>
            <a:prstGeom prst="rect">
              <a:avLst/>
            </a:prstGeom>
          </p:spPr>
        </p:pic>
        <p:pic>
          <p:nvPicPr>
            <p:cNvPr id="473" name="Immagine 472">
              <a:extLst>
                <a:ext uri="{FF2B5EF4-FFF2-40B4-BE49-F238E27FC236}">
                  <a16:creationId xmlns:a16="http://schemas.microsoft.com/office/drawing/2014/main" id="{56A84147-1F7E-4071-8DEC-FC3CA9D8908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duotone>
                <a:schemeClr val="bg2">
                  <a:shade val="45000"/>
                  <a:satMod val="135000"/>
                </a:schemeClr>
                <a:prstClr val="white"/>
              </a:duotone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ackgroundRemoval t="0" b="100000" l="0" r="1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784066" y="16745731"/>
              <a:ext cx="285750" cy="285750"/>
            </a:xfrm>
            <a:prstGeom prst="rect">
              <a:avLst/>
            </a:prstGeom>
          </p:spPr>
        </p:pic>
      </p:grpSp>
      <p:sp>
        <p:nvSpPr>
          <p:cNvPr id="408" name="CasellaDiTesto 482">
            <a:extLst>
              <a:ext uri="{FF2B5EF4-FFF2-40B4-BE49-F238E27FC236}">
                <a16:creationId xmlns:a16="http://schemas.microsoft.com/office/drawing/2014/main" id="{9F444A20-CD9A-46E9-A2A3-4ABCE9F26F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93376" y="402759"/>
            <a:ext cx="88104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9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Patient</a:t>
            </a:r>
            <a:endParaRPr kumimoji="0" lang="it-IT" altLang="it-IT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 </a:t>
            </a:r>
            <a:r>
              <a:rPr kumimoji="0" lang="it-IT" altLang="it-IT" sz="9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enrollment</a:t>
            </a:r>
            <a:endParaRPr kumimoji="0" lang="it-IT" altLang="it-IT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grpSp>
        <p:nvGrpSpPr>
          <p:cNvPr id="409" name="Gruppo 408">
            <a:extLst>
              <a:ext uri="{FF2B5EF4-FFF2-40B4-BE49-F238E27FC236}">
                <a16:creationId xmlns:a16="http://schemas.microsoft.com/office/drawing/2014/main" id="{7B138A57-7905-4CDC-BC3E-C6001F01A480}"/>
              </a:ext>
            </a:extLst>
          </p:cNvPr>
          <p:cNvGrpSpPr/>
          <p:nvPr/>
        </p:nvGrpSpPr>
        <p:grpSpPr>
          <a:xfrm flipH="1">
            <a:off x="2766841" y="867570"/>
            <a:ext cx="216000" cy="475200"/>
            <a:chOff x="12607615" y="16745731"/>
            <a:chExt cx="609600" cy="1228781"/>
          </a:xfrm>
        </p:grpSpPr>
        <p:pic>
          <p:nvPicPr>
            <p:cNvPr id="470" name="Immagine 469">
              <a:extLst>
                <a:ext uri="{FF2B5EF4-FFF2-40B4-BE49-F238E27FC236}">
                  <a16:creationId xmlns:a16="http://schemas.microsoft.com/office/drawing/2014/main" id="{FA7F628A-61A3-4EEE-8BAD-2411E2950DB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0" b="100000" l="1563" r="1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607615" y="16755312"/>
              <a:ext cx="609600" cy="1219200"/>
            </a:xfrm>
            <a:prstGeom prst="rect">
              <a:avLst/>
            </a:prstGeom>
          </p:spPr>
        </p:pic>
        <p:pic>
          <p:nvPicPr>
            <p:cNvPr id="471" name="Immagine 470">
              <a:extLst>
                <a:ext uri="{FF2B5EF4-FFF2-40B4-BE49-F238E27FC236}">
                  <a16:creationId xmlns:a16="http://schemas.microsoft.com/office/drawing/2014/main" id="{59351A40-CB67-4CDA-B293-8C39BFCBBEC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ackgroundRemoval t="0" b="100000" l="0" r="1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784066" y="16745731"/>
              <a:ext cx="285750" cy="285750"/>
            </a:xfrm>
            <a:prstGeom prst="rect">
              <a:avLst/>
            </a:prstGeom>
          </p:spPr>
        </p:pic>
      </p:grpSp>
      <p:sp>
        <p:nvSpPr>
          <p:cNvPr id="410" name="CasellaDiTesto 482">
            <a:extLst>
              <a:ext uri="{FF2B5EF4-FFF2-40B4-BE49-F238E27FC236}">
                <a16:creationId xmlns:a16="http://schemas.microsoft.com/office/drawing/2014/main" id="{F2891F43-0D47-41CC-974C-C021836E51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82295" y="1196861"/>
            <a:ext cx="41491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70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T</a:t>
            </a:r>
            <a:r>
              <a:rPr kumimoji="0" lang="it-IT" altLang="it-IT" sz="700" i="0" u="none" strike="noStrike" kern="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1</a:t>
            </a:r>
          </a:p>
        </p:txBody>
      </p:sp>
      <p:grpSp>
        <p:nvGrpSpPr>
          <p:cNvPr id="411" name="Gruppo 410">
            <a:extLst>
              <a:ext uri="{FF2B5EF4-FFF2-40B4-BE49-F238E27FC236}">
                <a16:creationId xmlns:a16="http://schemas.microsoft.com/office/drawing/2014/main" id="{9CA71883-371E-493D-AC76-FC878EF38D5E}"/>
              </a:ext>
            </a:extLst>
          </p:cNvPr>
          <p:cNvGrpSpPr/>
          <p:nvPr/>
        </p:nvGrpSpPr>
        <p:grpSpPr>
          <a:xfrm flipH="1">
            <a:off x="3336975" y="867570"/>
            <a:ext cx="216000" cy="475200"/>
            <a:chOff x="12607615" y="16745731"/>
            <a:chExt cx="609600" cy="1228781"/>
          </a:xfrm>
        </p:grpSpPr>
        <p:pic>
          <p:nvPicPr>
            <p:cNvPr id="468" name="Immagine 467">
              <a:extLst>
                <a:ext uri="{FF2B5EF4-FFF2-40B4-BE49-F238E27FC236}">
                  <a16:creationId xmlns:a16="http://schemas.microsoft.com/office/drawing/2014/main" id="{152FADBA-44E2-456A-A3F0-35F75BFD57F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0" b="100000" l="1563" r="1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607615" y="16755312"/>
              <a:ext cx="609600" cy="1219200"/>
            </a:xfrm>
            <a:prstGeom prst="rect">
              <a:avLst/>
            </a:prstGeom>
          </p:spPr>
        </p:pic>
        <p:pic>
          <p:nvPicPr>
            <p:cNvPr id="469" name="Immagine 468">
              <a:extLst>
                <a:ext uri="{FF2B5EF4-FFF2-40B4-BE49-F238E27FC236}">
                  <a16:creationId xmlns:a16="http://schemas.microsoft.com/office/drawing/2014/main" id="{52C33F97-56C3-43E6-AE8E-B3F634C4CD2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ackgroundRemoval t="0" b="100000" l="0" r="1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784066" y="16745731"/>
              <a:ext cx="285750" cy="285750"/>
            </a:xfrm>
            <a:prstGeom prst="rect">
              <a:avLst/>
            </a:prstGeom>
          </p:spPr>
        </p:pic>
      </p:grpSp>
      <p:grpSp>
        <p:nvGrpSpPr>
          <p:cNvPr id="413" name="Gruppo 412">
            <a:extLst>
              <a:ext uri="{FF2B5EF4-FFF2-40B4-BE49-F238E27FC236}">
                <a16:creationId xmlns:a16="http://schemas.microsoft.com/office/drawing/2014/main" id="{5762164F-CC48-48EC-927F-328CC5971AB3}"/>
              </a:ext>
            </a:extLst>
          </p:cNvPr>
          <p:cNvGrpSpPr/>
          <p:nvPr/>
        </p:nvGrpSpPr>
        <p:grpSpPr>
          <a:xfrm flipH="1">
            <a:off x="3893227" y="867570"/>
            <a:ext cx="216000" cy="475200"/>
            <a:chOff x="12607615" y="16745731"/>
            <a:chExt cx="609600" cy="1228781"/>
          </a:xfrm>
        </p:grpSpPr>
        <p:pic>
          <p:nvPicPr>
            <p:cNvPr id="466" name="Immagine 465">
              <a:extLst>
                <a:ext uri="{FF2B5EF4-FFF2-40B4-BE49-F238E27FC236}">
                  <a16:creationId xmlns:a16="http://schemas.microsoft.com/office/drawing/2014/main" id="{81FD7587-221A-42A4-82DD-8F683B1CDCD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0" b="100000" l="1563" r="1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607615" y="16755312"/>
              <a:ext cx="609600" cy="1219200"/>
            </a:xfrm>
            <a:prstGeom prst="rect">
              <a:avLst/>
            </a:prstGeom>
          </p:spPr>
        </p:pic>
        <p:pic>
          <p:nvPicPr>
            <p:cNvPr id="467" name="Immagine 466">
              <a:extLst>
                <a:ext uri="{FF2B5EF4-FFF2-40B4-BE49-F238E27FC236}">
                  <a16:creationId xmlns:a16="http://schemas.microsoft.com/office/drawing/2014/main" id="{3FC315C3-0FD7-4734-BC39-056EEA9B62A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ackgroundRemoval t="0" b="100000" l="0" r="1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784066" y="16745731"/>
              <a:ext cx="285750" cy="285750"/>
            </a:xfrm>
            <a:prstGeom prst="rect">
              <a:avLst/>
            </a:prstGeom>
          </p:spPr>
        </p:pic>
      </p:grpSp>
      <p:sp>
        <p:nvSpPr>
          <p:cNvPr id="415" name="CasellaDiTesto 482">
            <a:extLst>
              <a:ext uri="{FF2B5EF4-FFF2-40B4-BE49-F238E27FC236}">
                <a16:creationId xmlns:a16="http://schemas.microsoft.com/office/drawing/2014/main" id="{EFD492BC-3AC7-4789-ABFF-7FF3C548D6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98385" y="1095824"/>
            <a:ext cx="59681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7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Baseline</a:t>
            </a:r>
          </a:p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it-IT" altLang="it-IT" sz="700" i="1" kern="0" dirty="0">
                <a:solidFill>
                  <a:prstClr val="black"/>
                </a:solidFill>
                <a:latin typeface="+mn-lt"/>
              </a:rPr>
              <a:t>(T</a:t>
            </a:r>
            <a:r>
              <a:rPr lang="it-IT" altLang="it-IT" sz="700" i="1" kern="0" baseline="-25000" dirty="0">
                <a:solidFill>
                  <a:prstClr val="black"/>
                </a:solidFill>
                <a:latin typeface="+mn-lt"/>
              </a:rPr>
              <a:t>0</a:t>
            </a:r>
            <a:r>
              <a:rPr lang="it-IT" altLang="it-IT" sz="700" i="1" kern="0" dirty="0">
                <a:solidFill>
                  <a:prstClr val="black"/>
                </a:solidFill>
                <a:latin typeface="+mn-lt"/>
              </a:rPr>
              <a:t>)</a:t>
            </a:r>
            <a:endParaRPr kumimoji="0" lang="it-IT" altLang="it-IT" sz="700" i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416" name="CasellaDiTesto 482">
            <a:extLst>
              <a:ext uri="{FF2B5EF4-FFF2-40B4-BE49-F238E27FC236}">
                <a16:creationId xmlns:a16="http://schemas.microsoft.com/office/drawing/2014/main" id="{F0D75B64-7FC3-4B6C-A567-FF8B6BCA1B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77310" y="1095824"/>
            <a:ext cx="6352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700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Progression</a:t>
            </a:r>
            <a:endParaRPr kumimoji="0" lang="it-IT" altLang="it-IT" sz="700" i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it-IT" altLang="it-IT" sz="700" i="1" kern="0" dirty="0">
                <a:solidFill>
                  <a:prstClr val="black"/>
                </a:solidFill>
                <a:latin typeface="+mn-lt"/>
              </a:rPr>
              <a:t>(</a:t>
            </a:r>
            <a:r>
              <a:rPr lang="it-IT" altLang="it-IT" sz="700" i="1" kern="0" dirty="0" err="1">
                <a:solidFill>
                  <a:prstClr val="black"/>
                </a:solidFill>
                <a:latin typeface="+mn-lt"/>
              </a:rPr>
              <a:t>T</a:t>
            </a:r>
            <a:r>
              <a:rPr lang="it-IT" altLang="it-IT" sz="700" i="1" kern="0" baseline="-25000" dirty="0" err="1">
                <a:solidFill>
                  <a:prstClr val="black"/>
                </a:solidFill>
                <a:latin typeface="+mn-lt"/>
              </a:rPr>
              <a:t>p</a:t>
            </a:r>
            <a:r>
              <a:rPr lang="it-IT" altLang="it-IT" sz="700" i="1" kern="0" dirty="0">
                <a:solidFill>
                  <a:prstClr val="black"/>
                </a:solidFill>
                <a:latin typeface="+mn-lt"/>
              </a:rPr>
              <a:t>)</a:t>
            </a:r>
            <a:endParaRPr kumimoji="0" lang="it-IT" altLang="it-IT" sz="700" i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417" name="Freccia a destra 416">
            <a:extLst>
              <a:ext uri="{FF2B5EF4-FFF2-40B4-BE49-F238E27FC236}">
                <a16:creationId xmlns:a16="http://schemas.microsoft.com/office/drawing/2014/main" id="{5EF78257-015E-42A7-A4BB-683FFACEDA32}"/>
              </a:ext>
            </a:extLst>
          </p:cNvPr>
          <p:cNvSpPr/>
          <p:nvPr/>
        </p:nvSpPr>
        <p:spPr>
          <a:xfrm>
            <a:off x="2022159" y="1346362"/>
            <a:ext cx="3520058" cy="155797"/>
          </a:xfrm>
          <a:prstGeom prst="rightArrow">
            <a:avLst>
              <a:gd name="adj1" fmla="val 50000"/>
              <a:gd name="adj2" fmla="val 50000"/>
            </a:avLst>
          </a:prstGeom>
          <a:gradFill flip="none" rotWithShape="1">
            <a:gsLst>
              <a:gs pos="0">
                <a:schemeClr val="accent2">
                  <a:lumMod val="5000"/>
                  <a:lumOff val="95000"/>
                </a:schemeClr>
              </a:gs>
              <a:gs pos="23000">
                <a:schemeClr val="accent4">
                  <a:lumMod val="40000"/>
                  <a:lumOff val="60000"/>
                </a:schemeClr>
              </a:gs>
              <a:gs pos="43000">
                <a:schemeClr val="accent2">
                  <a:lumMod val="60000"/>
                  <a:lumOff val="40000"/>
                </a:schemeClr>
              </a:gs>
              <a:gs pos="76000">
                <a:srgbClr val="C00000"/>
              </a:gs>
            </a:gsLst>
            <a:lin ang="0" scaled="1"/>
            <a:tileRect/>
          </a:gra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200"/>
          </a:p>
        </p:txBody>
      </p:sp>
      <p:sp>
        <p:nvSpPr>
          <p:cNvPr id="436" name="Parentesi graffa chiusa 435">
            <a:extLst>
              <a:ext uri="{FF2B5EF4-FFF2-40B4-BE49-F238E27FC236}">
                <a16:creationId xmlns:a16="http://schemas.microsoft.com/office/drawing/2014/main" id="{83DA6035-FD77-41F0-BDA0-FE09CBE8934E}"/>
              </a:ext>
            </a:extLst>
          </p:cNvPr>
          <p:cNvSpPr/>
          <p:nvPr/>
        </p:nvSpPr>
        <p:spPr>
          <a:xfrm rot="5400000">
            <a:off x="3084873" y="-467842"/>
            <a:ext cx="155798" cy="4927559"/>
          </a:xfrm>
          <a:prstGeom prst="rightBrace">
            <a:avLst>
              <a:gd name="adj1" fmla="val 69553"/>
              <a:gd name="adj2" fmla="val 49742"/>
            </a:avLst>
          </a:prstGeom>
          <a:noFill/>
          <a:ln w="9525" cap="flat" cmpd="sng" algn="ctr">
            <a:solidFill>
              <a:sysClr val="windowText" lastClr="000000"/>
            </a:solidFill>
            <a:prstDash val="solid"/>
            <a:headEnd type="none"/>
            <a:tailEnd type="none"/>
          </a:ln>
          <a:effectLst/>
        </p:spPr>
        <p:txBody>
          <a:bodyPr rtlCol="0" anchor="ctr"/>
          <a:lstStyle/>
          <a:p>
            <a:pPr algn="ctr"/>
            <a:endParaRPr lang="it-IT" sz="1200" dirty="0"/>
          </a:p>
        </p:txBody>
      </p:sp>
      <p:pic>
        <p:nvPicPr>
          <p:cNvPr id="438" name="Immagine 437">
            <a:extLst>
              <a:ext uri="{FF2B5EF4-FFF2-40B4-BE49-F238E27FC236}">
                <a16:creationId xmlns:a16="http://schemas.microsoft.com/office/drawing/2014/main" id="{EFD5DD3F-2592-454D-9379-A6BFD7806CB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ackgroundRemoval t="3846" b="96154" l="2381" r="95238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045101" y="997296"/>
            <a:ext cx="46523" cy="43200"/>
          </a:xfrm>
          <a:prstGeom prst="rect">
            <a:avLst/>
          </a:prstGeom>
        </p:spPr>
      </p:pic>
      <p:pic>
        <p:nvPicPr>
          <p:cNvPr id="439" name="Immagine 438">
            <a:extLst>
              <a:ext uri="{FF2B5EF4-FFF2-40B4-BE49-F238E27FC236}">
                <a16:creationId xmlns:a16="http://schemas.microsoft.com/office/drawing/2014/main" id="{42B972DF-C485-4587-AEA7-2947F5E27211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ackgroundRemoval t="2632" b="98684" l="2532" r="96203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76951" y="1004142"/>
            <a:ext cx="44905" cy="43200"/>
          </a:xfrm>
          <a:prstGeom prst="rect">
            <a:avLst/>
          </a:prstGeom>
        </p:spPr>
      </p:pic>
      <p:pic>
        <p:nvPicPr>
          <p:cNvPr id="440" name="Immagine 439">
            <a:extLst>
              <a:ext uri="{FF2B5EF4-FFF2-40B4-BE49-F238E27FC236}">
                <a16:creationId xmlns:a16="http://schemas.microsoft.com/office/drawing/2014/main" id="{BBF3BDB4-A6F4-4726-9B78-567EE0621B5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ackgroundRemoval t="2632" b="98684" l="2532" r="96203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V="1">
            <a:off x="3447626" y="1001147"/>
            <a:ext cx="44905" cy="43200"/>
          </a:xfrm>
          <a:prstGeom prst="rect">
            <a:avLst/>
          </a:prstGeom>
        </p:spPr>
      </p:pic>
      <p:pic>
        <p:nvPicPr>
          <p:cNvPr id="441" name="Immagine 440">
            <a:extLst>
              <a:ext uri="{FF2B5EF4-FFF2-40B4-BE49-F238E27FC236}">
                <a16:creationId xmlns:a16="http://schemas.microsoft.com/office/drawing/2014/main" id="{7DBFDEF6-A814-4274-AFA1-8A0D84EAA887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ackgroundRemoval t="2597" b="98701" l="0" r="92135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73686" y="1049337"/>
            <a:ext cx="24966" cy="21600"/>
          </a:xfrm>
          <a:prstGeom prst="rect">
            <a:avLst/>
          </a:prstGeom>
        </p:spPr>
      </p:pic>
      <p:pic>
        <p:nvPicPr>
          <p:cNvPr id="442" name="Immagine 441">
            <a:extLst>
              <a:ext uri="{FF2B5EF4-FFF2-40B4-BE49-F238E27FC236}">
                <a16:creationId xmlns:a16="http://schemas.microsoft.com/office/drawing/2014/main" id="{81D1983E-D8AD-4895-86E5-40D775E07A51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ackgroundRemoval t="2632" b="98684" l="2532" r="96203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3990493" y="988163"/>
            <a:ext cx="67358" cy="64800"/>
          </a:xfrm>
          <a:prstGeom prst="rect">
            <a:avLst/>
          </a:prstGeom>
        </p:spPr>
      </p:pic>
      <p:grpSp>
        <p:nvGrpSpPr>
          <p:cNvPr id="443" name="Gruppo 442">
            <a:extLst>
              <a:ext uri="{FF2B5EF4-FFF2-40B4-BE49-F238E27FC236}">
                <a16:creationId xmlns:a16="http://schemas.microsoft.com/office/drawing/2014/main" id="{43902E3D-791B-4EAC-9F7C-10145F362E18}"/>
              </a:ext>
            </a:extLst>
          </p:cNvPr>
          <p:cNvGrpSpPr/>
          <p:nvPr/>
        </p:nvGrpSpPr>
        <p:grpSpPr>
          <a:xfrm flipH="1">
            <a:off x="5398532" y="867570"/>
            <a:ext cx="216000" cy="475200"/>
            <a:chOff x="12607615" y="16745731"/>
            <a:chExt cx="609600" cy="1228781"/>
          </a:xfrm>
        </p:grpSpPr>
        <p:pic>
          <p:nvPicPr>
            <p:cNvPr id="464" name="Immagine 463">
              <a:extLst>
                <a:ext uri="{FF2B5EF4-FFF2-40B4-BE49-F238E27FC236}">
                  <a16:creationId xmlns:a16="http://schemas.microsoft.com/office/drawing/2014/main" id="{723A7964-460D-4A09-AB51-361F04E366B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0" b="100000" l="1563" r="1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607615" y="16755312"/>
              <a:ext cx="609600" cy="1219200"/>
            </a:xfrm>
            <a:prstGeom prst="rect">
              <a:avLst/>
            </a:prstGeom>
          </p:spPr>
        </p:pic>
        <p:pic>
          <p:nvPicPr>
            <p:cNvPr id="465" name="Immagine 464">
              <a:extLst>
                <a:ext uri="{FF2B5EF4-FFF2-40B4-BE49-F238E27FC236}">
                  <a16:creationId xmlns:a16="http://schemas.microsoft.com/office/drawing/2014/main" id="{CCAEDDCB-1966-474C-A445-14FAC7957D1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ackgroundRemoval t="0" b="100000" l="0" r="1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784066" y="16745731"/>
              <a:ext cx="285750" cy="285750"/>
            </a:xfrm>
            <a:prstGeom prst="rect">
              <a:avLst/>
            </a:prstGeom>
          </p:spPr>
        </p:pic>
      </p:grpSp>
      <p:pic>
        <p:nvPicPr>
          <p:cNvPr id="449" name="Immagine 448">
            <a:extLst>
              <a:ext uri="{FF2B5EF4-FFF2-40B4-BE49-F238E27FC236}">
                <a16:creationId xmlns:a16="http://schemas.microsoft.com/office/drawing/2014/main" id="{34C3242E-BE53-4220-BC72-7AFF9F46326C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ackgroundRemoval t="2597" b="98701" l="0" r="92135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471984" y="1049337"/>
            <a:ext cx="24966" cy="21600"/>
          </a:xfrm>
          <a:prstGeom prst="rect">
            <a:avLst/>
          </a:prstGeom>
        </p:spPr>
      </p:pic>
      <p:pic>
        <p:nvPicPr>
          <p:cNvPr id="450" name="Immagine 449">
            <a:extLst>
              <a:ext uri="{FF2B5EF4-FFF2-40B4-BE49-F238E27FC236}">
                <a16:creationId xmlns:a16="http://schemas.microsoft.com/office/drawing/2014/main" id="{6C8050F5-1BFA-45D2-916D-841F54BA417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ackgroundRemoval t="2632" b="98684" l="2532" r="96203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5498700" y="986250"/>
            <a:ext cx="67358" cy="64800"/>
          </a:xfrm>
          <a:prstGeom prst="rect">
            <a:avLst/>
          </a:prstGeom>
        </p:spPr>
      </p:pic>
      <p:pic>
        <p:nvPicPr>
          <p:cNvPr id="452" name="Immagine 451">
            <a:extLst>
              <a:ext uri="{FF2B5EF4-FFF2-40B4-BE49-F238E27FC236}">
                <a16:creationId xmlns:a16="http://schemas.microsoft.com/office/drawing/2014/main" id="{226C9964-E6D1-419D-B9FD-A6A5E4E0A0BB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ackgroundRemoval t="2597" b="98701" l="0" r="92135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452136" y="1005768"/>
            <a:ext cx="24966" cy="21600"/>
          </a:xfrm>
          <a:prstGeom prst="rect">
            <a:avLst/>
          </a:prstGeom>
        </p:spPr>
      </p:pic>
      <p:pic>
        <p:nvPicPr>
          <p:cNvPr id="453" name="Immagine 452">
            <a:extLst>
              <a:ext uri="{FF2B5EF4-FFF2-40B4-BE49-F238E27FC236}">
                <a16:creationId xmlns:a16="http://schemas.microsoft.com/office/drawing/2014/main" id="{2DB6884B-6A7A-4BAE-B949-26C3165484F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ackgroundRemoval t="3846" b="96154" l="2381" r="95238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537883" y="1035462"/>
            <a:ext cx="23262" cy="21600"/>
          </a:xfrm>
          <a:prstGeom prst="rect">
            <a:avLst/>
          </a:prstGeom>
        </p:spPr>
      </p:pic>
      <p:pic>
        <p:nvPicPr>
          <p:cNvPr id="454" name="Immagine 453">
            <a:extLst>
              <a:ext uri="{FF2B5EF4-FFF2-40B4-BE49-F238E27FC236}">
                <a16:creationId xmlns:a16="http://schemas.microsoft.com/office/drawing/2014/main" id="{A09CEFFD-A633-4099-8421-0F14816A3E48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ackgroundRemoval t="2597" b="98701" l="0" r="92135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478927" y="1039514"/>
            <a:ext cx="24966" cy="21600"/>
          </a:xfrm>
          <a:prstGeom prst="rect">
            <a:avLst/>
          </a:prstGeom>
        </p:spPr>
      </p:pic>
      <p:pic>
        <p:nvPicPr>
          <p:cNvPr id="455" name="Immagine 454">
            <a:extLst>
              <a:ext uri="{FF2B5EF4-FFF2-40B4-BE49-F238E27FC236}">
                <a16:creationId xmlns:a16="http://schemas.microsoft.com/office/drawing/2014/main" id="{7D231A06-58DC-4DD4-9830-AB61F76E9F6A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ackgroundRemoval t="2597" b="98701" l="0" r="92135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462643" y="1038004"/>
            <a:ext cx="24966" cy="21600"/>
          </a:xfrm>
          <a:prstGeom prst="rect">
            <a:avLst/>
          </a:prstGeom>
        </p:spPr>
      </p:pic>
      <p:sp>
        <p:nvSpPr>
          <p:cNvPr id="487" name="CasellaDiTesto 482">
            <a:extLst>
              <a:ext uri="{FF2B5EF4-FFF2-40B4-BE49-F238E27FC236}">
                <a16:creationId xmlns:a16="http://schemas.microsoft.com/office/drawing/2014/main" id="{BD20D3AA-94BE-47DD-8453-DF93ABF9BA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25517" y="472009"/>
            <a:ext cx="171235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T-DM1 </a:t>
            </a:r>
            <a:r>
              <a:rPr kumimoji="0" lang="it-IT" altLang="it-IT" sz="9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administrations</a:t>
            </a:r>
            <a:endParaRPr kumimoji="0" lang="it-IT" altLang="it-IT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488" name="CasellaDiTesto 483">
            <a:extLst>
              <a:ext uri="{FF2B5EF4-FFF2-40B4-BE49-F238E27FC236}">
                <a16:creationId xmlns:a16="http://schemas.microsoft.com/office/drawing/2014/main" id="{AA74C4B7-939D-4668-9374-BAE9477BD0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73806" y="1515050"/>
            <a:ext cx="52437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it-IT" altLang="it-IT" sz="700" kern="0" dirty="0">
                <a:solidFill>
                  <a:prstClr val="black"/>
                </a:solidFill>
              </a:rPr>
              <a:t>EDTA </a:t>
            </a:r>
            <a:r>
              <a:rPr lang="it-IT" altLang="it-IT" sz="700" kern="0" dirty="0" err="1">
                <a:solidFill>
                  <a:prstClr val="black"/>
                </a:solidFill>
              </a:rPr>
              <a:t>tubes</a:t>
            </a:r>
            <a:endParaRPr kumimoji="0" lang="it-IT" altLang="it-IT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MS PGothic" panose="020B0600070205080204" pitchFamily="34" charset="-128"/>
            </a:endParaRPr>
          </a:p>
        </p:txBody>
      </p:sp>
      <p:sp>
        <p:nvSpPr>
          <p:cNvPr id="8" name="Rettangolo 7">
            <a:extLst>
              <a:ext uri="{FF2B5EF4-FFF2-40B4-BE49-F238E27FC236}">
                <a16:creationId xmlns:a16="http://schemas.microsoft.com/office/drawing/2014/main" id="{AB8A1707-0504-4324-8CB6-250649072171}"/>
              </a:ext>
            </a:extLst>
          </p:cNvPr>
          <p:cNvSpPr/>
          <p:nvPr/>
        </p:nvSpPr>
        <p:spPr>
          <a:xfrm>
            <a:off x="4858811" y="1369119"/>
            <a:ext cx="45719" cy="1102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90" name="Rettangolo 489">
            <a:extLst>
              <a:ext uri="{FF2B5EF4-FFF2-40B4-BE49-F238E27FC236}">
                <a16:creationId xmlns:a16="http://schemas.microsoft.com/office/drawing/2014/main" id="{5391B97B-94A6-413E-A24D-C1D3E86F9B70}"/>
              </a:ext>
            </a:extLst>
          </p:cNvPr>
          <p:cNvSpPr/>
          <p:nvPr/>
        </p:nvSpPr>
        <p:spPr>
          <a:xfrm>
            <a:off x="4969504" y="1369119"/>
            <a:ext cx="45719" cy="1102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91" name="Rettangolo 490">
            <a:extLst>
              <a:ext uri="{FF2B5EF4-FFF2-40B4-BE49-F238E27FC236}">
                <a16:creationId xmlns:a16="http://schemas.microsoft.com/office/drawing/2014/main" id="{9E4B17FF-6C2E-48D2-B36E-82E22039AE53}"/>
              </a:ext>
            </a:extLst>
          </p:cNvPr>
          <p:cNvSpPr/>
          <p:nvPr/>
        </p:nvSpPr>
        <p:spPr>
          <a:xfrm>
            <a:off x="5077817" y="1369119"/>
            <a:ext cx="45719" cy="1102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506" name="Gruppo 505">
            <a:extLst>
              <a:ext uri="{FF2B5EF4-FFF2-40B4-BE49-F238E27FC236}">
                <a16:creationId xmlns:a16="http://schemas.microsoft.com/office/drawing/2014/main" id="{DD734DB6-0CC4-4B4D-88EF-56DA971FCE47}"/>
              </a:ext>
            </a:extLst>
          </p:cNvPr>
          <p:cNvGrpSpPr/>
          <p:nvPr/>
        </p:nvGrpSpPr>
        <p:grpSpPr>
          <a:xfrm flipH="1">
            <a:off x="4479719" y="872560"/>
            <a:ext cx="216000" cy="475200"/>
            <a:chOff x="12607615" y="16745731"/>
            <a:chExt cx="609600" cy="1228781"/>
          </a:xfrm>
        </p:grpSpPr>
        <p:pic>
          <p:nvPicPr>
            <p:cNvPr id="507" name="Immagine 506">
              <a:extLst>
                <a:ext uri="{FF2B5EF4-FFF2-40B4-BE49-F238E27FC236}">
                  <a16:creationId xmlns:a16="http://schemas.microsoft.com/office/drawing/2014/main" id="{A15CD404-F2E2-4EEA-91EC-A5981925E33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0" b="100000" l="1563" r="1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607615" y="16755312"/>
              <a:ext cx="609600" cy="1219200"/>
            </a:xfrm>
            <a:prstGeom prst="rect">
              <a:avLst/>
            </a:prstGeom>
          </p:spPr>
        </p:pic>
        <p:pic>
          <p:nvPicPr>
            <p:cNvPr id="508" name="Immagine 507">
              <a:extLst>
                <a:ext uri="{FF2B5EF4-FFF2-40B4-BE49-F238E27FC236}">
                  <a16:creationId xmlns:a16="http://schemas.microsoft.com/office/drawing/2014/main" id="{C43227EE-A375-4343-8940-A5786BCBCEB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ackgroundRemoval t="0" b="100000" l="0" r="1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784066" y="16745731"/>
              <a:ext cx="285750" cy="285750"/>
            </a:xfrm>
            <a:prstGeom prst="rect">
              <a:avLst/>
            </a:prstGeom>
          </p:spPr>
        </p:pic>
      </p:grpSp>
      <p:pic>
        <p:nvPicPr>
          <p:cNvPr id="514" name="Immagine 513">
            <a:extLst>
              <a:ext uri="{FF2B5EF4-FFF2-40B4-BE49-F238E27FC236}">
                <a16:creationId xmlns:a16="http://schemas.microsoft.com/office/drawing/2014/main" id="{1FDEECD1-4E6B-4516-A763-D9B2B1FC365A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ackgroundRemoval t="2597" b="98701" l="0" r="92135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53171" y="1054327"/>
            <a:ext cx="24966" cy="21600"/>
          </a:xfrm>
          <a:prstGeom prst="rect">
            <a:avLst/>
          </a:prstGeom>
        </p:spPr>
      </p:pic>
      <p:pic>
        <p:nvPicPr>
          <p:cNvPr id="515" name="Immagine 514">
            <a:extLst>
              <a:ext uri="{FF2B5EF4-FFF2-40B4-BE49-F238E27FC236}">
                <a16:creationId xmlns:a16="http://schemas.microsoft.com/office/drawing/2014/main" id="{2354FEA3-9F02-472D-B8EC-02FA7C5DDF2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ackgroundRemoval t="2632" b="98684" l="2532" r="96203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4579887" y="991240"/>
            <a:ext cx="67358" cy="64800"/>
          </a:xfrm>
          <a:prstGeom prst="rect">
            <a:avLst/>
          </a:prstGeom>
        </p:spPr>
      </p:pic>
      <p:pic>
        <p:nvPicPr>
          <p:cNvPr id="517" name="Immagine 516">
            <a:extLst>
              <a:ext uri="{FF2B5EF4-FFF2-40B4-BE49-F238E27FC236}">
                <a16:creationId xmlns:a16="http://schemas.microsoft.com/office/drawing/2014/main" id="{7A701D7A-F094-48BC-AC11-B36379652EAD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ackgroundRemoval t="2597" b="98701" l="0" r="92135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33323" y="1010758"/>
            <a:ext cx="24966" cy="21600"/>
          </a:xfrm>
          <a:prstGeom prst="rect">
            <a:avLst/>
          </a:prstGeom>
        </p:spPr>
      </p:pic>
      <p:pic>
        <p:nvPicPr>
          <p:cNvPr id="518" name="Immagine 517">
            <a:extLst>
              <a:ext uri="{FF2B5EF4-FFF2-40B4-BE49-F238E27FC236}">
                <a16:creationId xmlns:a16="http://schemas.microsoft.com/office/drawing/2014/main" id="{F0D83661-8C44-45C7-A5EE-A07DFDC29CA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ackgroundRemoval t="3846" b="96154" l="2381" r="95238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619070" y="1040452"/>
            <a:ext cx="23262" cy="21600"/>
          </a:xfrm>
          <a:prstGeom prst="rect">
            <a:avLst/>
          </a:prstGeom>
        </p:spPr>
      </p:pic>
      <p:sp>
        <p:nvSpPr>
          <p:cNvPr id="525" name="CasellaDiTesto 482">
            <a:extLst>
              <a:ext uri="{FF2B5EF4-FFF2-40B4-BE49-F238E27FC236}">
                <a16:creationId xmlns:a16="http://schemas.microsoft.com/office/drawing/2014/main" id="{6ED17BD0-C7D6-431B-8E6B-67B7E7F423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3371" y="402759"/>
            <a:ext cx="88104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End of treatment</a:t>
            </a:r>
          </a:p>
        </p:txBody>
      </p:sp>
      <p:pic>
        <p:nvPicPr>
          <p:cNvPr id="527" name="Immagine 526">
            <a:extLst>
              <a:ext uri="{FF2B5EF4-FFF2-40B4-BE49-F238E27FC236}">
                <a16:creationId xmlns:a16="http://schemas.microsoft.com/office/drawing/2014/main" id="{A2EAB13A-57FB-4E83-B5B9-83FA0DCE1D72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ackgroundRemoval t="2646" b="98413" l="8511" r="89362">
                        <a14:foregroundMark x1="23404" y1="9524" x2="23404" y2="9524"/>
                        <a14:foregroundMark x1="65957" y1="8466" x2="65957" y2="8466"/>
                        <a14:foregroundMark x1="74468" y1="8466" x2="74468" y2="8466"/>
                        <a14:foregroundMark x1="70213" y1="4233" x2="70213" y2="4233"/>
                        <a14:foregroundMark x1="63830" y1="2646" x2="63830" y2="2646"/>
                        <a14:foregroundMark x1="40426" y1="91534" x2="40426" y2="91534"/>
                        <a14:foregroundMark x1="55319" y1="93122" x2="55319" y2="93122"/>
                        <a14:foregroundMark x1="51064" y1="96296" x2="51064" y2="96296"/>
                        <a14:foregroundMark x1="82979" y1="48148" x2="82979" y2="48148"/>
                        <a14:foregroundMark x1="85106" y1="56085" x2="85106" y2="56085"/>
                        <a14:foregroundMark x1="82979" y1="62963" x2="82979" y2="62963"/>
                        <a14:foregroundMark x1="82979" y1="71429" x2="82979" y2="71429"/>
                        <a14:foregroundMark x1="80851" y1="78307" x2="80851" y2="78307"/>
                        <a14:foregroundMark x1="51064" y1="97884" x2="51064" y2="97884"/>
                        <a14:foregroundMark x1="42553" y1="98413" x2="42553" y2="98413"/>
                        <a14:foregroundMark x1="29787" y1="96825" x2="29787" y2="96825"/>
                        <a14:foregroundMark x1="23404" y1="94709" x2="23404" y2="94709"/>
                        <a14:foregroundMark x1="14894" y1="90476" x2="14894" y2="90476"/>
                        <a14:foregroundMark x1="17021" y1="86772" x2="17021" y2="86772"/>
                        <a14:foregroundMark x1="17021" y1="83069" x2="17021" y2="83069"/>
                        <a14:foregroundMark x1="17021" y1="79894" x2="17021" y2="79894"/>
                        <a14:foregroundMark x1="14894" y1="76190" x2="14894" y2="76190"/>
                        <a14:foregroundMark x1="14894" y1="72487" x2="14894" y2="72487"/>
                        <a14:foregroundMark x1="14894" y1="68783" x2="14894" y2="68783"/>
                        <a14:foregroundMark x1="14894" y1="65079" x2="14894" y2="65079"/>
                        <a14:foregroundMark x1="14894" y1="60847" x2="14894" y2="60847"/>
                        <a14:foregroundMark x1="14894" y1="56614" x2="14894" y2="56614"/>
                        <a14:foregroundMark x1="14894" y1="52910" x2="14894" y2="52910"/>
                        <a14:foregroundMark x1="14894" y1="49735" x2="14894" y2="49735"/>
                        <a14:foregroundMark x1="14894" y1="46561" x2="14894" y2="46561"/>
                        <a14:foregroundMark x1="42553" y1="15344" x2="42553" y2="15344"/>
                        <a14:foregroundMark x1="57447" y1="13757" x2="57447" y2="13757"/>
                        <a14:foregroundMark x1="63830" y1="16402" x2="63830" y2="16402"/>
                        <a14:foregroundMark x1="38298" y1="2646" x2="38298" y2="2646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081121">
            <a:off x="2644149" y="1536725"/>
            <a:ext cx="80573" cy="324000"/>
          </a:xfrm>
          <a:prstGeom prst="rect">
            <a:avLst/>
          </a:prstGeom>
        </p:spPr>
      </p:pic>
      <p:pic>
        <p:nvPicPr>
          <p:cNvPr id="528" name="Immagine 527">
            <a:extLst>
              <a:ext uri="{FF2B5EF4-FFF2-40B4-BE49-F238E27FC236}">
                <a16:creationId xmlns:a16="http://schemas.microsoft.com/office/drawing/2014/main" id="{EA638E34-F27C-480C-8A2F-8345A4D28A64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ackgroundRemoval t="2646" b="98413" l="8511" r="89362">
                        <a14:foregroundMark x1="23404" y1="9524" x2="23404" y2="9524"/>
                        <a14:foregroundMark x1="65957" y1="8466" x2="65957" y2="8466"/>
                        <a14:foregroundMark x1="74468" y1="8466" x2="74468" y2="8466"/>
                        <a14:foregroundMark x1="70213" y1="4233" x2="70213" y2="4233"/>
                        <a14:foregroundMark x1="63830" y1="2646" x2="63830" y2="2646"/>
                        <a14:foregroundMark x1="40426" y1="91534" x2="40426" y2="91534"/>
                        <a14:foregroundMark x1="55319" y1="93122" x2="55319" y2="93122"/>
                        <a14:foregroundMark x1="51064" y1="96296" x2="51064" y2="96296"/>
                        <a14:foregroundMark x1="82979" y1="48148" x2="82979" y2="48148"/>
                        <a14:foregroundMark x1="85106" y1="56085" x2="85106" y2="56085"/>
                        <a14:foregroundMark x1="82979" y1="62963" x2="82979" y2="62963"/>
                        <a14:foregroundMark x1="82979" y1="71429" x2="82979" y2="71429"/>
                        <a14:foregroundMark x1="80851" y1="78307" x2="80851" y2="78307"/>
                        <a14:foregroundMark x1="51064" y1="97884" x2="51064" y2="97884"/>
                        <a14:foregroundMark x1="42553" y1="98413" x2="42553" y2="98413"/>
                        <a14:foregroundMark x1="29787" y1="96825" x2="29787" y2="96825"/>
                        <a14:foregroundMark x1="23404" y1="94709" x2="23404" y2="94709"/>
                        <a14:foregroundMark x1="14894" y1="90476" x2="14894" y2="90476"/>
                        <a14:foregroundMark x1="17021" y1="86772" x2="17021" y2="86772"/>
                        <a14:foregroundMark x1="17021" y1="83069" x2="17021" y2="83069"/>
                        <a14:foregroundMark x1="17021" y1="79894" x2="17021" y2="79894"/>
                        <a14:foregroundMark x1="14894" y1="76190" x2="14894" y2="76190"/>
                        <a14:foregroundMark x1="14894" y1="72487" x2="14894" y2="72487"/>
                        <a14:foregroundMark x1="14894" y1="68783" x2="14894" y2="68783"/>
                        <a14:foregroundMark x1="14894" y1="65079" x2="14894" y2="65079"/>
                        <a14:foregroundMark x1="14894" y1="60847" x2="14894" y2="60847"/>
                        <a14:foregroundMark x1="14894" y1="56614" x2="14894" y2="56614"/>
                        <a14:foregroundMark x1="14894" y1="52910" x2="14894" y2="52910"/>
                        <a14:foregroundMark x1="14894" y1="49735" x2="14894" y2="49735"/>
                        <a14:foregroundMark x1="14894" y1="46561" x2="14894" y2="46561"/>
                        <a14:foregroundMark x1="42553" y1="15344" x2="42553" y2="15344"/>
                        <a14:foregroundMark x1="57447" y1="13757" x2="57447" y2="13757"/>
                        <a14:foregroundMark x1="63830" y1="16402" x2="63830" y2="16402"/>
                        <a14:foregroundMark x1="38298" y1="2646" x2="38298" y2="2646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081121">
            <a:off x="3235754" y="1536725"/>
            <a:ext cx="80573" cy="324000"/>
          </a:xfrm>
          <a:prstGeom prst="rect">
            <a:avLst/>
          </a:prstGeom>
        </p:spPr>
      </p:pic>
      <p:pic>
        <p:nvPicPr>
          <p:cNvPr id="529" name="Immagine 528">
            <a:extLst>
              <a:ext uri="{FF2B5EF4-FFF2-40B4-BE49-F238E27FC236}">
                <a16:creationId xmlns:a16="http://schemas.microsoft.com/office/drawing/2014/main" id="{C268E528-C46E-43FE-AB36-0DD328DA8AB8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ackgroundRemoval t="2646" b="98413" l="8511" r="89362">
                        <a14:foregroundMark x1="23404" y1="9524" x2="23404" y2="9524"/>
                        <a14:foregroundMark x1="65957" y1="8466" x2="65957" y2="8466"/>
                        <a14:foregroundMark x1="74468" y1="8466" x2="74468" y2="8466"/>
                        <a14:foregroundMark x1="70213" y1="4233" x2="70213" y2="4233"/>
                        <a14:foregroundMark x1="63830" y1="2646" x2="63830" y2="2646"/>
                        <a14:foregroundMark x1="40426" y1="91534" x2="40426" y2="91534"/>
                        <a14:foregroundMark x1="55319" y1="93122" x2="55319" y2="93122"/>
                        <a14:foregroundMark x1="51064" y1="96296" x2="51064" y2="96296"/>
                        <a14:foregroundMark x1="82979" y1="48148" x2="82979" y2="48148"/>
                        <a14:foregroundMark x1="85106" y1="56085" x2="85106" y2="56085"/>
                        <a14:foregroundMark x1="82979" y1="62963" x2="82979" y2="62963"/>
                        <a14:foregroundMark x1="82979" y1="71429" x2="82979" y2="71429"/>
                        <a14:foregroundMark x1="80851" y1="78307" x2="80851" y2="78307"/>
                        <a14:foregroundMark x1="51064" y1="97884" x2="51064" y2="97884"/>
                        <a14:foregroundMark x1="42553" y1="98413" x2="42553" y2="98413"/>
                        <a14:foregroundMark x1="29787" y1="96825" x2="29787" y2="96825"/>
                        <a14:foregroundMark x1="23404" y1="94709" x2="23404" y2="94709"/>
                        <a14:foregroundMark x1="14894" y1="90476" x2="14894" y2="90476"/>
                        <a14:foregroundMark x1="17021" y1="86772" x2="17021" y2="86772"/>
                        <a14:foregroundMark x1="17021" y1="83069" x2="17021" y2="83069"/>
                        <a14:foregroundMark x1="17021" y1="79894" x2="17021" y2="79894"/>
                        <a14:foregroundMark x1="14894" y1="76190" x2="14894" y2="76190"/>
                        <a14:foregroundMark x1="14894" y1="72487" x2="14894" y2="72487"/>
                        <a14:foregroundMark x1="14894" y1="68783" x2="14894" y2="68783"/>
                        <a14:foregroundMark x1="14894" y1="65079" x2="14894" y2="65079"/>
                        <a14:foregroundMark x1="14894" y1="60847" x2="14894" y2="60847"/>
                        <a14:foregroundMark x1="14894" y1="56614" x2="14894" y2="56614"/>
                        <a14:foregroundMark x1="14894" y1="52910" x2="14894" y2="52910"/>
                        <a14:foregroundMark x1="14894" y1="49735" x2="14894" y2="49735"/>
                        <a14:foregroundMark x1="14894" y1="46561" x2="14894" y2="46561"/>
                        <a14:foregroundMark x1="42553" y1="15344" x2="42553" y2="15344"/>
                        <a14:foregroundMark x1="57447" y1="13757" x2="57447" y2="13757"/>
                        <a14:foregroundMark x1="63830" y1="16402" x2="63830" y2="16402"/>
                        <a14:foregroundMark x1="38298" y1="2646" x2="38298" y2="2646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081121">
            <a:off x="3791331" y="1536725"/>
            <a:ext cx="80573" cy="324000"/>
          </a:xfrm>
          <a:prstGeom prst="rect">
            <a:avLst/>
          </a:prstGeom>
        </p:spPr>
      </p:pic>
      <p:pic>
        <p:nvPicPr>
          <p:cNvPr id="530" name="Immagine 529">
            <a:extLst>
              <a:ext uri="{FF2B5EF4-FFF2-40B4-BE49-F238E27FC236}">
                <a16:creationId xmlns:a16="http://schemas.microsoft.com/office/drawing/2014/main" id="{23A55350-BC8B-4531-8FF6-319B4EA2E8DE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ackgroundRemoval t="2646" b="98413" l="8511" r="89362">
                        <a14:foregroundMark x1="23404" y1="9524" x2="23404" y2="9524"/>
                        <a14:foregroundMark x1="65957" y1="8466" x2="65957" y2="8466"/>
                        <a14:foregroundMark x1="74468" y1="8466" x2="74468" y2="8466"/>
                        <a14:foregroundMark x1="70213" y1="4233" x2="70213" y2="4233"/>
                        <a14:foregroundMark x1="63830" y1="2646" x2="63830" y2="2646"/>
                        <a14:foregroundMark x1="40426" y1="91534" x2="40426" y2="91534"/>
                        <a14:foregroundMark x1="55319" y1="93122" x2="55319" y2="93122"/>
                        <a14:foregroundMark x1="51064" y1="96296" x2="51064" y2="96296"/>
                        <a14:foregroundMark x1="82979" y1="48148" x2="82979" y2="48148"/>
                        <a14:foregroundMark x1="85106" y1="56085" x2="85106" y2="56085"/>
                        <a14:foregroundMark x1="82979" y1="62963" x2="82979" y2="62963"/>
                        <a14:foregroundMark x1="82979" y1="71429" x2="82979" y2="71429"/>
                        <a14:foregroundMark x1="80851" y1="78307" x2="80851" y2="78307"/>
                        <a14:foregroundMark x1="51064" y1="97884" x2="51064" y2="97884"/>
                        <a14:foregroundMark x1="42553" y1="98413" x2="42553" y2="98413"/>
                        <a14:foregroundMark x1="29787" y1="96825" x2="29787" y2="96825"/>
                        <a14:foregroundMark x1="23404" y1="94709" x2="23404" y2="94709"/>
                        <a14:foregroundMark x1="14894" y1="90476" x2="14894" y2="90476"/>
                        <a14:foregroundMark x1="17021" y1="86772" x2="17021" y2="86772"/>
                        <a14:foregroundMark x1="17021" y1="83069" x2="17021" y2="83069"/>
                        <a14:foregroundMark x1="17021" y1="79894" x2="17021" y2="79894"/>
                        <a14:foregroundMark x1="14894" y1="76190" x2="14894" y2="76190"/>
                        <a14:foregroundMark x1="14894" y1="72487" x2="14894" y2="72487"/>
                        <a14:foregroundMark x1="14894" y1="68783" x2="14894" y2="68783"/>
                        <a14:foregroundMark x1="14894" y1="65079" x2="14894" y2="65079"/>
                        <a14:foregroundMark x1="14894" y1="60847" x2="14894" y2="60847"/>
                        <a14:foregroundMark x1="14894" y1="56614" x2="14894" y2="56614"/>
                        <a14:foregroundMark x1="14894" y1="52910" x2="14894" y2="52910"/>
                        <a14:foregroundMark x1="14894" y1="49735" x2="14894" y2="49735"/>
                        <a14:foregroundMark x1="14894" y1="46561" x2="14894" y2="46561"/>
                        <a14:foregroundMark x1="42553" y1="15344" x2="42553" y2="15344"/>
                        <a14:foregroundMark x1="57447" y1="13757" x2="57447" y2="13757"/>
                        <a14:foregroundMark x1="63830" y1="16402" x2="63830" y2="16402"/>
                        <a14:foregroundMark x1="38298" y1="2646" x2="38298" y2="2646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081121">
            <a:off x="4369228" y="1536725"/>
            <a:ext cx="80573" cy="324000"/>
          </a:xfrm>
          <a:prstGeom prst="rect">
            <a:avLst/>
          </a:prstGeom>
        </p:spPr>
      </p:pic>
      <p:pic>
        <p:nvPicPr>
          <p:cNvPr id="532" name="Immagine 531">
            <a:extLst>
              <a:ext uri="{FF2B5EF4-FFF2-40B4-BE49-F238E27FC236}">
                <a16:creationId xmlns:a16="http://schemas.microsoft.com/office/drawing/2014/main" id="{38BE7A1A-098F-47B6-A762-3B4FD7EDCAA0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ackgroundRemoval t="2646" b="98413" l="8511" r="89362">
                        <a14:foregroundMark x1="23404" y1="9524" x2="23404" y2="9524"/>
                        <a14:foregroundMark x1="65957" y1="8466" x2="65957" y2="8466"/>
                        <a14:foregroundMark x1="74468" y1="8466" x2="74468" y2="8466"/>
                        <a14:foregroundMark x1="70213" y1="4233" x2="70213" y2="4233"/>
                        <a14:foregroundMark x1="63830" y1="2646" x2="63830" y2="2646"/>
                        <a14:foregroundMark x1="40426" y1="91534" x2="40426" y2="91534"/>
                        <a14:foregroundMark x1="55319" y1="93122" x2="55319" y2="93122"/>
                        <a14:foregroundMark x1="51064" y1="96296" x2="51064" y2="96296"/>
                        <a14:foregroundMark x1="82979" y1="48148" x2="82979" y2="48148"/>
                        <a14:foregroundMark x1="85106" y1="56085" x2="85106" y2="56085"/>
                        <a14:foregroundMark x1="82979" y1="62963" x2="82979" y2="62963"/>
                        <a14:foregroundMark x1="82979" y1="71429" x2="82979" y2="71429"/>
                        <a14:foregroundMark x1="80851" y1="78307" x2="80851" y2="78307"/>
                        <a14:foregroundMark x1="51064" y1="97884" x2="51064" y2="97884"/>
                        <a14:foregroundMark x1="42553" y1="98413" x2="42553" y2="98413"/>
                        <a14:foregroundMark x1="29787" y1="96825" x2="29787" y2="96825"/>
                        <a14:foregroundMark x1="23404" y1="94709" x2="23404" y2="94709"/>
                        <a14:foregroundMark x1="14894" y1="90476" x2="14894" y2="90476"/>
                        <a14:foregroundMark x1="17021" y1="86772" x2="17021" y2="86772"/>
                        <a14:foregroundMark x1="17021" y1="83069" x2="17021" y2="83069"/>
                        <a14:foregroundMark x1="17021" y1="79894" x2="17021" y2="79894"/>
                        <a14:foregroundMark x1="14894" y1="76190" x2="14894" y2="76190"/>
                        <a14:foregroundMark x1="14894" y1="72487" x2="14894" y2="72487"/>
                        <a14:foregroundMark x1="14894" y1="68783" x2="14894" y2="68783"/>
                        <a14:foregroundMark x1="14894" y1="65079" x2="14894" y2="65079"/>
                        <a14:foregroundMark x1="14894" y1="60847" x2="14894" y2="60847"/>
                        <a14:foregroundMark x1="14894" y1="56614" x2="14894" y2="56614"/>
                        <a14:foregroundMark x1="14894" y1="52910" x2="14894" y2="52910"/>
                        <a14:foregroundMark x1="14894" y1="49735" x2="14894" y2="49735"/>
                        <a14:foregroundMark x1="14894" y1="46561" x2="14894" y2="46561"/>
                        <a14:foregroundMark x1="42553" y1="15344" x2="42553" y2="15344"/>
                        <a14:foregroundMark x1="57447" y1="13757" x2="57447" y2="13757"/>
                        <a14:foregroundMark x1="63830" y1="16402" x2="63830" y2="16402"/>
                        <a14:foregroundMark x1="38298" y1="2646" x2="38298" y2="2646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081121">
            <a:off x="5150309" y="1536725"/>
            <a:ext cx="80573" cy="324000"/>
          </a:xfrm>
          <a:prstGeom prst="rect">
            <a:avLst/>
          </a:prstGeom>
        </p:spPr>
      </p:pic>
      <p:pic>
        <p:nvPicPr>
          <p:cNvPr id="109" name="Immagine 108">
            <a:extLst>
              <a:ext uri="{FF2B5EF4-FFF2-40B4-BE49-F238E27FC236}">
                <a16:creationId xmlns:a16="http://schemas.microsoft.com/office/drawing/2014/main" id="{43860775-B81C-455C-9194-249A3F9B71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99273" y="1625579"/>
            <a:ext cx="258749" cy="180000"/>
          </a:xfrm>
          <a:prstGeom prst="rect">
            <a:avLst/>
          </a:prstGeom>
        </p:spPr>
      </p:pic>
      <p:sp>
        <p:nvSpPr>
          <p:cNvPr id="136" name="CasellaDiTesto 482">
            <a:extLst>
              <a:ext uri="{FF2B5EF4-FFF2-40B4-BE49-F238E27FC236}">
                <a16:creationId xmlns:a16="http://schemas.microsoft.com/office/drawing/2014/main" id="{B7E32117-F1A6-4E57-BFBE-E9FF1065DC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4593" y="1458438"/>
            <a:ext cx="390518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7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-20</a:t>
            </a:r>
          </a:p>
        </p:txBody>
      </p:sp>
      <p:sp>
        <p:nvSpPr>
          <p:cNvPr id="138" name="CasellaDiTesto 2429">
            <a:extLst>
              <a:ext uri="{FF2B5EF4-FFF2-40B4-BE49-F238E27FC236}">
                <a16:creationId xmlns:a16="http://schemas.microsoft.com/office/drawing/2014/main" id="{D02F87A3-D063-448F-84C6-93B9B8D99D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26042" y="1528505"/>
            <a:ext cx="63522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lvl="0" algn="ctr" defTabSz="914400" eaLnBrk="0" fontAlgn="base" hangingPunct="0">
              <a:spcBef>
                <a:spcPct val="0"/>
              </a:spcBef>
              <a:spcAft>
                <a:spcPct val="0"/>
              </a:spcAft>
              <a:buNone/>
            </a:pPr>
            <a:r>
              <a:rPr lang="it-IT" altLang="it-IT" sz="900" b="1" kern="0" dirty="0">
                <a:solidFill>
                  <a:prstClr val="black"/>
                </a:solidFill>
                <a:latin typeface="+mn-lt"/>
              </a:rPr>
              <a:t>Tumor re-</a:t>
            </a:r>
            <a:r>
              <a:rPr lang="it-IT" altLang="it-IT" sz="900" b="1" kern="0" dirty="0" err="1">
                <a:solidFill>
                  <a:prstClr val="black"/>
                </a:solidFill>
                <a:latin typeface="+mn-lt"/>
              </a:rPr>
              <a:t>biopsy</a:t>
            </a:r>
            <a:endParaRPr lang="it-IT" altLang="it-IT" sz="900" b="1" kern="0" dirty="0">
              <a:solidFill>
                <a:prstClr val="black"/>
              </a:solidFill>
              <a:latin typeface="+mn-lt"/>
            </a:endParaRPr>
          </a:p>
        </p:txBody>
      </p:sp>
      <p:pic>
        <p:nvPicPr>
          <p:cNvPr id="143" name="Immagine 142">
            <a:extLst>
              <a:ext uri="{FF2B5EF4-FFF2-40B4-BE49-F238E27FC236}">
                <a16:creationId xmlns:a16="http://schemas.microsoft.com/office/drawing/2014/main" id="{7FF859CD-5853-4444-9776-002BCE9D7E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17758" y="1153040"/>
            <a:ext cx="258749" cy="180000"/>
          </a:xfrm>
          <a:prstGeom prst="rect">
            <a:avLst/>
          </a:prstGeom>
        </p:spPr>
      </p:pic>
      <p:pic>
        <p:nvPicPr>
          <p:cNvPr id="144" name="Immagine 143">
            <a:extLst>
              <a:ext uri="{FF2B5EF4-FFF2-40B4-BE49-F238E27FC236}">
                <a16:creationId xmlns:a16="http://schemas.microsoft.com/office/drawing/2014/main" id="{6D6096F9-6BF8-4B57-8362-F32E20A69C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7471" y="1156083"/>
            <a:ext cx="258749" cy="180000"/>
          </a:xfrm>
          <a:prstGeom prst="rect">
            <a:avLst/>
          </a:prstGeom>
        </p:spPr>
      </p:pic>
      <p:sp>
        <p:nvSpPr>
          <p:cNvPr id="145" name="Freccia a destra 144">
            <a:extLst>
              <a:ext uri="{FF2B5EF4-FFF2-40B4-BE49-F238E27FC236}">
                <a16:creationId xmlns:a16="http://schemas.microsoft.com/office/drawing/2014/main" id="{FA6BE66A-A6B7-4159-BCBF-CB49911761C5}"/>
              </a:ext>
            </a:extLst>
          </p:cNvPr>
          <p:cNvSpPr/>
          <p:nvPr/>
        </p:nvSpPr>
        <p:spPr>
          <a:xfrm>
            <a:off x="673594" y="1345252"/>
            <a:ext cx="979154" cy="15579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bg1">
              <a:lumMod val="7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200"/>
          </a:p>
        </p:txBody>
      </p:sp>
      <p:sp>
        <p:nvSpPr>
          <p:cNvPr id="146" name="CasellaDiTesto 482">
            <a:extLst>
              <a:ext uri="{FF2B5EF4-FFF2-40B4-BE49-F238E27FC236}">
                <a16:creationId xmlns:a16="http://schemas.microsoft.com/office/drawing/2014/main" id="{9390B284-66D0-4FB6-BA20-0556DF6539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62691" y="1458438"/>
            <a:ext cx="49536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7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-1</a:t>
            </a:r>
          </a:p>
        </p:txBody>
      </p:sp>
      <p:sp>
        <p:nvSpPr>
          <p:cNvPr id="147" name="CasellaDiTesto 482">
            <a:extLst>
              <a:ext uri="{FF2B5EF4-FFF2-40B4-BE49-F238E27FC236}">
                <a16:creationId xmlns:a16="http://schemas.microsoft.com/office/drawing/2014/main" id="{B42B735D-78B2-45EF-84AF-403360CABC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8979" y="1458438"/>
            <a:ext cx="59681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700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years</a:t>
            </a:r>
            <a:endParaRPr kumimoji="0" lang="it-IT" altLang="it-IT" sz="700" i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pic>
        <p:nvPicPr>
          <p:cNvPr id="161" name="Picture 10" descr="QuantStudio™ 3D Digital PCR System Package, with Master Mix, Chip Kit v2,  and customer site training">
            <a:extLst>
              <a:ext uri="{FF2B5EF4-FFF2-40B4-BE49-F238E27FC236}">
                <a16:creationId xmlns:a16="http://schemas.microsoft.com/office/drawing/2014/main" id="{6496698B-F8BA-4FD8-A00E-0671EE6A14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783980" y="2074655"/>
            <a:ext cx="944034" cy="79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62" name="Connettore 2 161">
            <a:extLst>
              <a:ext uri="{FF2B5EF4-FFF2-40B4-BE49-F238E27FC236}">
                <a16:creationId xmlns:a16="http://schemas.microsoft.com/office/drawing/2014/main" id="{EA4E97BD-26DA-4A96-92C4-C155A22EC4CC}"/>
              </a:ext>
            </a:extLst>
          </p:cNvPr>
          <p:cNvCxnSpPr>
            <a:cxnSpLocks/>
          </p:cNvCxnSpPr>
          <p:nvPr/>
        </p:nvCxnSpPr>
        <p:spPr>
          <a:xfrm>
            <a:off x="3469130" y="2387920"/>
            <a:ext cx="360000" cy="0"/>
          </a:xfrm>
          <a:prstGeom prst="straightConnector1">
            <a:avLst/>
          </a:prstGeom>
          <a:noFill/>
          <a:ln w="9525" cap="flat" cmpd="sng" algn="ctr">
            <a:solidFill>
              <a:sysClr val="windowText" lastClr="000000"/>
            </a:solidFill>
            <a:prstDash val="dash"/>
            <a:headEnd type="none"/>
            <a:tailEnd type="stealth"/>
          </a:ln>
          <a:effectLst/>
        </p:spPr>
      </p:cxnSp>
      <p:sp>
        <p:nvSpPr>
          <p:cNvPr id="163" name="CasellaDiTesto 502">
            <a:extLst>
              <a:ext uri="{FF2B5EF4-FFF2-40B4-BE49-F238E27FC236}">
                <a16:creationId xmlns:a16="http://schemas.microsoft.com/office/drawing/2014/main" id="{8E933105-4BA6-4784-8C7B-D18B2B291681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558184" y="2248294"/>
            <a:ext cx="94403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it-IT" altLang="it-IT" sz="900" b="1" kern="0" dirty="0" err="1">
                <a:solidFill>
                  <a:prstClr val="black"/>
                </a:solidFill>
                <a:latin typeface="+mn-lt"/>
              </a:rPr>
              <a:t>Targeted</a:t>
            </a:r>
            <a:r>
              <a:rPr lang="it-IT" altLang="it-IT" sz="900" b="1" kern="0" dirty="0">
                <a:solidFill>
                  <a:prstClr val="black"/>
                </a:solidFill>
                <a:latin typeface="+mn-lt"/>
              </a:rPr>
              <a:t> </a:t>
            </a:r>
            <a:r>
              <a:rPr kumimoji="0" lang="it-IT" altLang="it-IT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NGS</a:t>
            </a:r>
          </a:p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(50 </a:t>
            </a:r>
            <a:r>
              <a:rPr kumimoji="0" lang="it-IT" altLang="it-IT" sz="9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genes</a:t>
            </a:r>
            <a:r>
              <a:rPr kumimoji="0" lang="it-IT" altLang="it-IT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)</a:t>
            </a:r>
          </a:p>
        </p:txBody>
      </p:sp>
      <p:cxnSp>
        <p:nvCxnSpPr>
          <p:cNvPr id="164" name="Connettore 2 163">
            <a:extLst>
              <a:ext uri="{FF2B5EF4-FFF2-40B4-BE49-F238E27FC236}">
                <a16:creationId xmlns:a16="http://schemas.microsoft.com/office/drawing/2014/main" id="{AD44C271-F8C9-4B13-8102-041B913EC415}"/>
              </a:ext>
            </a:extLst>
          </p:cNvPr>
          <p:cNvCxnSpPr>
            <a:cxnSpLocks/>
          </p:cNvCxnSpPr>
          <p:nvPr/>
        </p:nvCxnSpPr>
        <p:spPr>
          <a:xfrm flipH="1">
            <a:off x="2528728" y="2387920"/>
            <a:ext cx="360000" cy="0"/>
          </a:xfrm>
          <a:prstGeom prst="straightConnector1">
            <a:avLst/>
          </a:prstGeom>
          <a:noFill/>
          <a:ln w="9525" cap="flat" cmpd="sng" algn="ctr">
            <a:solidFill>
              <a:sysClr val="windowText" lastClr="000000"/>
            </a:solidFill>
            <a:prstDash val="dash"/>
            <a:headEnd type="none"/>
            <a:tailEnd type="stealth"/>
          </a:ln>
          <a:effectLst/>
        </p:spPr>
      </p:cxnSp>
      <p:pic>
        <p:nvPicPr>
          <p:cNvPr id="165" name="Immagine 164">
            <a:extLst>
              <a:ext uri="{FF2B5EF4-FFF2-40B4-BE49-F238E27FC236}">
                <a16:creationId xmlns:a16="http://schemas.microsoft.com/office/drawing/2014/main" id="{0ED37903-0EC0-474A-9515-4B1CA0FDB4EC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 flipH="1">
            <a:off x="2976696" y="2196920"/>
            <a:ext cx="407467" cy="382000"/>
          </a:xfrm>
          <a:prstGeom prst="rect">
            <a:avLst/>
          </a:prstGeom>
        </p:spPr>
      </p:pic>
      <p:sp>
        <p:nvSpPr>
          <p:cNvPr id="166" name="CasellaDiTesto 483">
            <a:extLst>
              <a:ext uri="{FF2B5EF4-FFF2-40B4-BE49-F238E27FC236}">
                <a16:creationId xmlns:a16="http://schemas.microsoft.com/office/drawing/2014/main" id="{50F457DE-58FF-4C3F-9E77-6527E46D2FB6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2922029" y="2578920"/>
            <a:ext cx="543677" cy="4154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7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MS PGothic" panose="020B0600070205080204" pitchFamily="34" charset="-128"/>
              </a:rPr>
              <a:t>tDNAs</a:t>
            </a:r>
            <a:endParaRPr kumimoji="0" lang="it-IT" altLang="it-IT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MS PGothic" panose="020B0600070205080204" pitchFamily="34" charset="-128"/>
            </a:endParaRPr>
          </a:p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it-IT" altLang="it-IT" sz="700" kern="0" dirty="0">
                <a:solidFill>
                  <a:prstClr val="black"/>
                </a:solidFill>
              </a:rPr>
              <a:t>and </a:t>
            </a:r>
            <a:r>
              <a:rPr lang="it-IT" altLang="it-IT" sz="700" kern="0" dirty="0" err="1">
                <a:solidFill>
                  <a:prstClr val="black"/>
                </a:solidFill>
              </a:rPr>
              <a:t>ctTNAs</a:t>
            </a:r>
            <a:endParaRPr kumimoji="0" lang="it-IT" altLang="it-IT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MS PGothic" panose="020B0600070205080204" pitchFamily="34" charset="-128"/>
            </a:endParaRPr>
          </a:p>
        </p:txBody>
      </p:sp>
      <p:pic>
        <p:nvPicPr>
          <p:cNvPr id="167" name="Picture 8" descr="ION GENESTUDIO S5 PRIME SYSTEM">
            <a:extLst>
              <a:ext uri="{FF2B5EF4-FFF2-40B4-BE49-F238E27FC236}">
                <a16:creationId xmlns:a16="http://schemas.microsoft.com/office/drawing/2014/main" id="{07D1387D-1446-4DC9-A677-1D21DE372BA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91" t="21128" r="14589" b="35831"/>
          <a:stretch/>
        </p:blipFill>
        <p:spPr bwMode="auto">
          <a:xfrm>
            <a:off x="1429994" y="2135500"/>
            <a:ext cx="1035406" cy="6434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9" name="CasellaDiTesto 502">
            <a:extLst>
              <a:ext uri="{FF2B5EF4-FFF2-40B4-BE49-F238E27FC236}">
                <a16:creationId xmlns:a16="http://schemas.microsoft.com/office/drawing/2014/main" id="{3CD15126-EFC5-4DDF-907F-FD1879C0ED88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595641" y="2248294"/>
            <a:ext cx="144923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dPCR </a:t>
            </a:r>
            <a:r>
              <a:rPr kumimoji="0" lang="it-IT" altLang="it-IT" sz="9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analysis</a:t>
            </a:r>
            <a:r>
              <a:rPr kumimoji="0" lang="it-IT" altLang="it-IT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 with </a:t>
            </a:r>
            <a:r>
              <a:rPr kumimoji="0" lang="it-IT" altLang="it-IT" sz="9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mutation-specifi</a:t>
            </a:r>
            <a:r>
              <a:rPr lang="it-IT" altLang="it-IT" sz="900" b="1" kern="0" dirty="0">
                <a:solidFill>
                  <a:prstClr val="black"/>
                </a:solidFill>
                <a:latin typeface="+mn-lt"/>
              </a:rPr>
              <a:t>c </a:t>
            </a:r>
            <a:r>
              <a:rPr lang="it-IT" altLang="it-IT" sz="900" b="1" kern="0" dirty="0" err="1">
                <a:solidFill>
                  <a:prstClr val="black"/>
                </a:solidFill>
                <a:latin typeface="+mn-lt"/>
              </a:rPr>
              <a:t>assay</a:t>
            </a:r>
            <a:endParaRPr kumimoji="0" lang="it-IT" altLang="it-IT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  <a:ea typeface="MS PGothic" panose="020B0600070205080204" pitchFamily="34" charset="-128"/>
            </a:endParaRPr>
          </a:p>
        </p:txBody>
      </p:sp>
      <p:sp>
        <p:nvSpPr>
          <p:cNvPr id="173" name="CasellaDiTesto 2429">
            <a:extLst>
              <a:ext uri="{FF2B5EF4-FFF2-40B4-BE49-F238E27FC236}">
                <a16:creationId xmlns:a16="http://schemas.microsoft.com/office/drawing/2014/main" id="{7A8CDD31-72C4-4EDA-8063-B318303CBA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78085" y="1442840"/>
            <a:ext cx="28727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lvl="0" algn="ctr" defTabSz="914400" eaLnBrk="0" fontAlgn="base" hangingPunct="0">
              <a:spcBef>
                <a:spcPct val="0"/>
              </a:spcBef>
              <a:spcAft>
                <a:spcPct val="0"/>
              </a:spcAft>
              <a:buNone/>
            </a:pPr>
            <a:r>
              <a:rPr lang="it-IT" altLang="it-IT" sz="900" b="1" kern="0" dirty="0">
                <a:solidFill>
                  <a:prstClr val="black"/>
                </a:solidFill>
                <a:latin typeface="+mn-lt"/>
              </a:rPr>
              <a:t>*</a:t>
            </a:r>
          </a:p>
        </p:txBody>
      </p:sp>
      <p:sp>
        <p:nvSpPr>
          <p:cNvPr id="174" name="CasellaDiTesto 2429">
            <a:extLst>
              <a:ext uri="{FF2B5EF4-FFF2-40B4-BE49-F238E27FC236}">
                <a16:creationId xmlns:a16="http://schemas.microsoft.com/office/drawing/2014/main" id="{0C294D0B-032B-4DCD-A360-4690C7CECE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08497" y="1442840"/>
            <a:ext cx="28727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lvl="0" algn="ctr" defTabSz="914400" eaLnBrk="0" fontAlgn="base" hangingPunct="0">
              <a:spcBef>
                <a:spcPct val="0"/>
              </a:spcBef>
              <a:spcAft>
                <a:spcPct val="0"/>
              </a:spcAft>
              <a:buNone/>
            </a:pPr>
            <a:r>
              <a:rPr lang="it-IT" altLang="it-IT" sz="900" b="1" kern="0" dirty="0">
                <a:solidFill>
                  <a:prstClr val="black"/>
                </a:solidFill>
                <a:latin typeface="+mn-lt"/>
              </a:rPr>
              <a:t>*</a:t>
            </a:r>
          </a:p>
        </p:txBody>
      </p:sp>
      <p:sp>
        <p:nvSpPr>
          <p:cNvPr id="175" name="CasellaDiTesto 2429">
            <a:extLst>
              <a:ext uri="{FF2B5EF4-FFF2-40B4-BE49-F238E27FC236}">
                <a16:creationId xmlns:a16="http://schemas.microsoft.com/office/drawing/2014/main" id="{A9275D6D-E105-4152-99FE-2CEE778F36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77291" y="1435192"/>
            <a:ext cx="28727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lvl="0" algn="ctr" defTabSz="914400" eaLnBrk="0" fontAlgn="base" hangingPunct="0">
              <a:spcBef>
                <a:spcPct val="0"/>
              </a:spcBef>
              <a:spcAft>
                <a:spcPct val="0"/>
              </a:spcAft>
              <a:buNone/>
            </a:pPr>
            <a:r>
              <a:rPr lang="it-IT" altLang="it-IT" sz="900" b="1" kern="0" dirty="0">
                <a:solidFill>
                  <a:prstClr val="black"/>
                </a:solidFill>
                <a:latin typeface="+mn-lt"/>
              </a:rPr>
              <a:t>*</a:t>
            </a:r>
          </a:p>
        </p:txBody>
      </p:sp>
      <p:sp>
        <p:nvSpPr>
          <p:cNvPr id="80" name="CasellaDiTesto 482">
            <a:extLst>
              <a:ext uri="{FF2B5EF4-FFF2-40B4-BE49-F238E27FC236}">
                <a16:creationId xmlns:a16="http://schemas.microsoft.com/office/drawing/2014/main" id="{FF6468D1-5C11-4C4E-B66C-CABD93E003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21264" y="1196861"/>
            <a:ext cx="41491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70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T</a:t>
            </a:r>
            <a:r>
              <a:rPr kumimoji="0" lang="it-IT" altLang="it-IT" sz="700" i="0" u="none" strike="noStrike" kern="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2</a:t>
            </a:r>
          </a:p>
        </p:txBody>
      </p:sp>
      <p:sp>
        <p:nvSpPr>
          <p:cNvPr id="81" name="CasellaDiTesto 482">
            <a:extLst>
              <a:ext uri="{FF2B5EF4-FFF2-40B4-BE49-F238E27FC236}">
                <a16:creationId xmlns:a16="http://schemas.microsoft.com/office/drawing/2014/main" id="{9D0B5B14-B5CB-4167-A119-03BA1CDA0D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11318" y="1196861"/>
            <a:ext cx="41491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70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T</a:t>
            </a:r>
            <a:r>
              <a:rPr kumimoji="0" lang="it-IT" altLang="it-IT" sz="700" i="0" u="none" strike="noStrike" kern="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MS PGothic" panose="020B0600070205080204" pitchFamily="34" charset="-128"/>
              </a:rPr>
              <a:t>n</a:t>
            </a:r>
          </a:p>
        </p:txBody>
      </p:sp>
      <p:sp>
        <p:nvSpPr>
          <p:cNvPr id="90" name="Rettangolo 89">
            <a:extLst>
              <a:ext uri="{FF2B5EF4-FFF2-40B4-BE49-F238E27FC236}">
                <a16:creationId xmlns:a16="http://schemas.microsoft.com/office/drawing/2014/main" id="{2005875E-A912-4489-9F3C-D9047D0FA654}"/>
              </a:ext>
            </a:extLst>
          </p:cNvPr>
          <p:cNvSpPr/>
          <p:nvPr/>
        </p:nvSpPr>
        <p:spPr>
          <a:xfrm>
            <a:off x="4075051" y="1369119"/>
            <a:ext cx="45719" cy="1102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1" name="Rettangolo 90">
            <a:extLst>
              <a:ext uri="{FF2B5EF4-FFF2-40B4-BE49-F238E27FC236}">
                <a16:creationId xmlns:a16="http://schemas.microsoft.com/office/drawing/2014/main" id="{FCAE2CAF-4A1E-4B36-ACF3-7CA6B1C09539}"/>
              </a:ext>
            </a:extLst>
          </p:cNvPr>
          <p:cNvSpPr/>
          <p:nvPr/>
        </p:nvSpPr>
        <p:spPr>
          <a:xfrm>
            <a:off x="4185744" y="1369119"/>
            <a:ext cx="45719" cy="1102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2" name="Rettangolo 91">
            <a:extLst>
              <a:ext uri="{FF2B5EF4-FFF2-40B4-BE49-F238E27FC236}">
                <a16:creationId xmlns:a16="http://schemas.microsoft.com/office/drawing/2014/main" id="{A10C5863-BBA0-48F6-A0B7-3243A02A4319}"/>
              </a:ext>
            </a:extLst>
          </p:cNvPr>
          <p:cNvSpPr/>
          <p:nvPr/>
        </p:nvSpPr>
        <p:spPr>
          <a:xfrm>
            <a:off x="4294057" y="1369119"/>
            <a:ext cx="45719" cy="1102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6" name="Connettore diritto 5">
            <a:extLst>
              <a:ext uri="{FF2B5EF4-FFF2-40B4-BE49-F238E27FC236}">
                <a16:creationId xmlns:a16="http://schemas.microsoft.com/office/drawing/2014/main" id="{69561E98-14D0-4987-99CF-483746FD2305}"/>
              </a:ext>
            </a:extLst>
          </p:cNvPr>
          <p:cNvCxnSpPr/>
          <p:nvPr/>
        </p:nvCxnSpPr>
        <p:spPr>
          <a:xfrm>
            <a:off x="3025518" y="701675"/>
            <a:ext cx="17123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375452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8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8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8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9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50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tteo Allegretti</dc:creator>
  <cp:lastModifiedBy>Matteo Allegretti</cp:lastModifiedBy>
  <cp:revision>28</cp:revision>
  <dcterms:created xsi:type="dcterms:W3CDTF">2020-01-05T15:31:16Z</dcterms:created>
  <dcterms:modified xsi:type="dcterms:W3CDTF">2021-04-26T12:30:48Z</dcterms:modified>
</cp:coreProperties>
</file>